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8" d="100"/>
          <a:sy n="48" d="100"/>
        </p:scale>
        <p:origin x="1320" y="5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228599" y="457200"/>
          <a:ext cx="8686801" cy="6019800"/>
        </p:xfrm>
        <a:graphic>
          <a:graphicData uri="http://schemas.openxmlformats.org/drawingml/2006/table">
            <a:tbl>
              <a:tblPr rtl="1"/>
              <a:tblGrid>
                <a:gridCol w="395952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70450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2277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203960">
                <a:tc>
                  <a:txBody>
                    <a:bodyPr/>
                    <a:lstStyle/>
                    <a:p>
                      <a:pPr algn="l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latin typeface="Calibri"/>
                          <a:ea typeface="Calibri"/>
                          <a:cs typeface="Arial"/>
                        </a:rPr>
                        <a:t>Reverse primers</a:t>
                      </a:r>
                      <a:endParaRPr lang="en-US" sz="1400" dirty="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>
                          <a:latin typeface="Calibri"/>
                          <a:ea typeface="Calibri"/>
                          <a:cs typeface="Arial"/>
                        </a:rPr>
                        <a:t>Forward primers</a:t>
                      </a:r>
                      <a:endParaRPr lang="en-US" sz="140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latin typeface="Calibri"/>
                          <a:ea typeface="Calibri"/>
                          <a:cs typeface="Arial"/>
                        </a:rPr>
                        <a:t>Gene</a:t>
                      </a:r>
                      <a:endParaRPr lang="en-US" sz="1400" dirty="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03960">
                <a:tc>
                  <a:txBody>
                    <a:bodyPr/>
                    <a:lstStyle/>
                    <a:p>
                      <a:pPr algn="l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latin typeface="Times New Roman"/>
                          <a:ea typeface="Calibri"/>
                          <a:cs typeface="Arial"/>
                        </a:rPr>
                        <a:t>5-GCAACTAAGTCATAGTCCGC-3</a:t>
                      </a:r>
                      <a:endParaRPr lang="en-US" sz="140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latin typeface="Times New Roman"/>
                          <a:ea typeface="Calibri"/>
                          <a:cs typeface="Arial"/>
                        </a:rPr>
                        <a:t>5-CTGTCTGCGGCACCACCAT-3</a:t>
                      </a:r>
                      <a:endParaRPr lang="en-US" sz="140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ar-EG" sz="1400" b="1" dirty="0">
                          <a:latin typeface="Calibri"/>
                          <a:ea typeface="Calibri"/>
                          <a:cs typeface="Arial"/>
                        </a:rPr>
                        <a:t>β</a:t>
                      </a:r>
                      <a:r>
                        <a:rPr lang="en-US" sz="1400" b="1" dirty="0">
                          <a:latin typeface="Arial"/>
                          <a:ea typeface="Calibri"/>
                          <a:cs typeface="Arial"/>
                        </a:rPr>
                        <a:t>-</a:t>
                      </a:r>
                      <a:r>
                        <a:rPr lang="en-US" sz="1400" b="1" dirty="0" err="1">
                          <a:latin typeface="Arial"/>
                          <a:ea typeface="Calibri"/>
                          <a:cs typeface="Arial"/>
                        </a:rPr>
                        <a:t>actin</a:t>
                      </a:r>
                      <a:endParaRPr lang="en-US" sz="1400" dirty="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03960">
                <a:tc>
                  <a:txBody>
                    <a:bodyPr/>
                    <a:lstStyle/>
                    <a:p>
                      <a:pPr algn="l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latin typeface="Cambria"/>
                          <a:ea typeface="Calibri"/>
                          <a:cs typeface="Times New Roman"/>
                        </a:rPr>
                        <a:t>5-TCCCGCCACAAAGATGGTCACG-3</a:t>
                      </a:r>
                      <a:endParaRPr lang="en-US" sz="140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latin typeface="Cambria"/>
                          <a:ea typeface="Calibri"/>
                          <a:cs typeface="Times New Roman"/>
                        </a:rPr>
                        <a:t>5-AAGCTGAGCGAGTGTCTCAAGCGC-3</a:t>
                      </a:r>
                      <a:endParaRPr lang="en-US" sz="1400" dirty="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latin typeface="Calibri"/>
                          <a:ea typeface="Calibri"/>
                          <a:cs typeface="Arial"/>
                        </a:rPr>
                        <a:t>BAX</a:t>
                      </a:r>
                      <a:endParaRPr lang="en-US" sz="1400" dirty="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03960">
                <a:tc>
                  <a:txBody>
                    <a:bodyPr/>
                    <a:lstStyle/>
                    <a:p>
                      <a:pPr algn="l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latin typeface="Times New Roman"/>
                          <a:ea typeface="Calibri"/>
                          <a:cs typeface="Arial"/>
                        </a:rPr>
                        <a:t>5-AGATAGGCACCCAGGGTGATGCAAGCT-3</a:t>
                      </a:r>
                      <a:endParaRPr lang="en-US" sz="140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latin typeface="Times New Roman"/>
                          <a:ea typeface="Calibri"/>
                          <a:cs typeface="Arial"/>
                        </a:rPr>
                        <a:t>5-AGATGCCAGCTGCACCTGAC-3</a:t>
                      </a:r>
                      <a:endParaRPr lang="en-US" sz="140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latin typeface="Calibri"/>
                          <a:ea typeface="Calibri"/>
                          <a:cs typeface="Arial"/>
                        </a:rPr>
                        <a:t>BCL2</a:t>
                      </a:r>
                      <a:endParaRPr lang="en-US" sz="1400" dirty="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03960">
                <a:tc>
                  <a:txBody>
                    <a:bodyPr/>
                    <a:lstStyle/>
                    <a:p>
                      <a:pPr algn="l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latin typeface="Times New Roman"/>
                          <a:ea typeface="Calibri"/>
                          <a:cs typeface="Arial"/>
                        </a:rPr>
                        <a:t>5-TCCCGCCACAAAGATGGTCACG-3</a:t>
                      </a:r>
                      <a:endParaRPr lang="en-US" sz="140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latin typeface="Times New Roman"/>
                          <a:ea typeface="Calibri"/>
                          <a:cs typeface="Arial"/>
                        </a:rPr>
                        <a:t>5-AGCTGAGCGAGTGTCTCAAGCGC-3</a:t>
                      </a:r>
                      <a:endParaRPr lang="en-US" sz="140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latin typeface="Calibri"/>
                          <a:ea typeface="Calibri"/>
                          <a:cs typeface="Arial"/>
                        </a:rPr>
                        <a:t>P53</a:t>
                      </a:r>
                      <a:endParaRPr lang="en-US" sz="1400" dirty="0">
                        <a:latin typeface="Calibri"/>
                        <a:ea typeface="Times New Roman"/>
                        <a:cs typeface="Arial"/>
                      </a:endParaRPr>
                    </a:p>
                  </a:txBody>
                  <a:tcPr marL="68260" marR="6826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14337" name="Rectangle 1"/>
          <p:cNvSpPr>
            <a:spLocks noChangeArrowheads="1"/>
          </p:cNvSpPr>
          <p:nvPr/>
        </p:nvSpPr>
        <p:spPr bwMode="auto">
          <a:xfrm>
            <a:off x="0" y="0"/>
            <a:ext cx="5637762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Table 2 Primer sequence for </a:t>
            </a:r>
            <a:r>
              <a:rPr kumimoji="0" lang="en-US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garose</a:t>
            </a:r>
            <a:r>
              <a:rPr kumimoji="0" lang="en-US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gel electrophoresis</a:t>
            </a:r>
            <a:endParaRPr kumimoji="0" lang="en-US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6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mbria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ci</dc:creator>
  <cp:lastModifiedBy>nub</cp:lastModifiedBy>
  <cp:revision>5</cp:revision>
  <dcterms:created xsi:type="dcterms:W3CDTF">2006-08-16T00:00:00Z</dcterms:created>
  <dcterms:modified xsi:type="dcterms:W3CDTF">2020-01-25T07:35:52Z</dcterms:modified>
</cp:coreProperties>
</file>